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-72" y="-72"/>
      </p:cViewPr>
      <p:guideLst>
        <p:guide orient="horz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875"/>
            <a:ext cx="1671638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6" y="396875"/>
            <a:ext cx="4849813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6" y="2311401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7301" y="2311401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1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1852BC-F851-471B-AE3A-F82227D59626}" type="datetimeFigureOut">
              <a:rPr lang="en-NZ" smtClean="0"/>
              <a:pPr/>
              <a:t>25/01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8ECA3-BDAE-4330-A78F-1A94DF555787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72480" y="980729"/>
          <a:ext cx="9361040" cy="238464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55370"/>
                <a:gridCol w="672822"/>
                <a:gridCol w="2016224"/>
                <a:gridCol w="792088"/>
                <a:gridCol w="2016224"/>
                <a:gridCol w="792088"/>
                <a:gridCol w="936104"/>
                <a:gridCol w="1080120"/>
              </a:tblGrid>
              <a:tr h="748912">
                <a:tc>
                  <a:txBody>
                    <a:bodyPr/>
                    <a:lstStyle/>
                    <a:p>
                      <a:pPr algn="ctr"/>
                      <a:r>
                        <a:rPr lang="en-NZ" sz="1050" b="1" dirty="0" smtClean="0"/>
                        <a:t>Target group</a:t>
                      </a:r>
                      <a:endParaRPr lang="en-NZ" sz="1050" b="1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NZ" sz="1050" b="1" dirty="0" smtClean="0"/>
                        <a:t>Forward Primer name</a:t>
                      </a:r>
                      <a:endParaRPr lang="en-NZ" sz="1050" b="1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NZ" sz="1050" b="1" dirty="0" smtClean="0"/>
                        <a:t>Forward primer sequence</a:t>
                      </a:r>
                      <a:r>
                        <a:rPr lang="en-NZ" sz="1050" b="1" baseline="0" dirty="0" smtClean="0"/>
                        <a:t> (5’-3’)</a:t>
                      </a:r>
                      <a:endParaRPr lang="en-NZ" sz="1050" b="1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NZ" sz="1050" b="1" dirty="0" smtClean="0"/>
                        <a:t>Reverse primer name</a:t>
                      </a:r>
                    </a:p>
                    <a:p>
                      <a:endParaRPr lang="en-NZ" sz="1050" b="1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NZ" sz="1050" b="1" dirty="0" smtClean="0"/>
                        <a:t>Reverse primer sequence</a:t>
                      </a:r>
                      <a:r>
                        <a:rPr lang="en-NZ" sz="1050" b="1" baseline="0" dirty="0" smtClean="0"/>
                        <a:t> (5’-3’)</a:t>
                      </a:r>
                      <a:endParaRPr lang="en-NZ" sz="1050" b="1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NZ" sz="1050" b="1" dirty="0" smtClean="0"/>
                        <a:t>Approx. </a:t>
                      </a:r>
                      <a:r>
                        <a:rPr lang="en-NZ" sz="1050" b="1" dirty="0" err="1" smtClean="0"/>
                        <a:t>amplicon</a:t>
                      </a:r>
                      <a:r>
                        <a:rPr lang="en-NZ" sz="1050" b="1" dirty="0" smtClean="0"/>
                        <a:t> length (</a:t>
                      </a:r>
                      <a:r>
                        <a:rPr lang="en-NZ" sz="1050" b="1" dirty="0" err="1" smtClean="0"/>
                        <a:t>bp</a:t>
                      </a:r>
                      <a:r>
                        <a:rPr lang="en-NZ" sz="1050" b="1" dirty="0" smtClean="0"/>
                        <a:t>)</a:t>
                      </a:r>
                      <a:endParaRPr lang="en-NZ" sz="1050" b="1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NZ" sz="1050" b="1" dirty="0" smtClean="0"/>
                        <a:t>Annealing temperature (</a:t>
                      </a:r>
                      <a:r>
                        <a:rPr lang="en-NZ" sz="1050" b="1" dirty="0" smtClean="0">
                          <a:latin typeface="Calibri"/>
                          <a:cs typeface="Calibri"/>
                        </a:rPr>
                        <a:t>°C)</a:t>
                      </a:r>
                      <a:endParaRPr lang="en-NZ" sz="1050" b="1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NZ" sz="1050" b="1" dirty="0" smtClean="0"/>
                        <a:t>Reference</a:t>
                      </a:r>
                      <a:endParaRPr lang="en-NZ" sz="1050" b="1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3581"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All</a:t>
                      </a:r>
                      <a:r>
                        <a:rPr lang="en-NZ" sz="1100" baseline="0" dirty="0" smtClean="0"/>
                        <a:t> </a:t>
                      </a:r>
                      <a:r>
                        <a:rPr lang="en-NZ" sz="1100" i="1" baseline="0" dirty="0" smtClean="0"/>
                        <a:t>Bacteria</a:t>
                      </a:r>
                      <a:endParaRPr lang="en-NZ" sz="1100" i="1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533F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CTA CCR GGG TAT CTA ATC C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NZ" sz="1100" dirty="0" smtClean="0"/>
                        <a:t>803R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GTG CCA GCA GCY GCG GTM A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290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59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err="1" smtClean="0"/>
                        <a:t>Nossa</a:t>
                      </a:r>
                      <a:r>
                        <a:rPr lang="en-NZ" sz="1100" dirty="0" smtClean="0"/>
                        <a:t> </a:t>
                      </a:r>
                      <a:r>
                        <a:rPr lang="en-NZ" sz="1100" i="1" dirty="0" smtClean="0"/>
                        <a:t>et al</a:t>
                      </a:r>
                      <a:r>
                        <a:rPr lang="en-NZ" sz="1100" dirty="0" smtClean="0"/>
                        <a:t>., (2010), </a:t>
                      </a:r>
                      <a:r>
                        <a:rPr lang="en-NZ" sz="1100" dirty="0" err="1" smtClean="0"/>
                        <a:t>Simister</a:t>
                      </a:r>
                      <a:r>
                        <a:rPr lang="en-NZ" sz="1100" dirty="0" smtClean="0"/>
                        <a:t> </a:t>
                      </a:r>
                      <a:r>
                        <a:rPr lang="en-NZ" sz="1100" i="1" dirty="0" smtClean="0"/>
                        <a:t>et</a:t>
                      </a:r>
                      <a:r>
                        <a:rPr lang="en-NZ" sz="1100" i="1" baseline="0" dirty="0" smtClean="0"/>
                        <a:t> al</a:t>
                      </a:r>
                      <a:r>
                        <a:rPr lang="en-NZ" sz="1100" baseline="0" dirty="0" smtClean="0"/>
                        <a:t>., (2012) 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436865">
                <a:tc>
                  <a:txBody>
                    <a:bodyPr/>
                    <a:lstStyle/>
                    <a:p>
                      <a:r>
                        <a:rPr lang="en-NZ" sz="1100" i="1" dirty="0" smtClean="0"/>
                        <a:t>Actinobacteria</a:t>
                      </a:r>
                      <a:endParaRPr lang="en-NZ" sz="1100" i="1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907F</a:t>
                      </a:r>
                      <a:endParaRPr lang="en-NZ" sz="1100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AAA CTY AAA KGA ATT GAC GG</a:t>
                      </a:r>
                      <a:endParaRPr lang="en-NZ" sz="1100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NZ" sz="1100" dirty="0" smtClean="0"/>
                        <a:t>Act1159R</a:t>
                      </a:r>
                      <a:endParaRPr lang="en-NZ" sz="1100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kern="1200" baseline="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CC GAG TTR ACC CCG GC</a:t>
                      </a:r>
                      <a:endParaRPr lang="en-NZ" sz="1100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270</a:t>
                      </a:r>
                      <a:endParaRPr lang="en-NZ" sz="1100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62</a:t>
                      </a:r>
                      <a:endParaRPr lang="en-NZ" sz="1100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err="1" smtClean="0"/>
                        <a:t>Eisenlord</a:t>
                      </a:r>
                      <a:r>
                        <a:rPr lang="en-NZ" sz="1100" dirty="0" smtClean="0"/>
                        <a:t> and Zak (2010)</a:t>
                      </a:r>
                      <a:endParaRPr lang="en-NZ" sz="1100" dirty="0"/>
                    </a:p>
                  </a:txBody>
                  <a:tcPr marL="99060" marR="990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6865">
                <a:tc>
                  <a:txBody>
                    <a:bodyPr/>
                    <a:lstStyle/>
                    <a:p>
                      <a:r>
                        <a:rPr lang="en-NZ" sz="1100" i="1" dirty="0" smtClean="0"/>
                        <a:t>Arthrobacter</a:t>
                      </a:r>
                      <a:endParaRPr lang="en-NZ" sz="1100" i="1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Art627F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GAT CTG CGG TGG GTA CGG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Art985R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CGG TTC ATG TCA AGC CTT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NZ" sz="1100" dirty="0" smtClean="0"/>
                        <a:t>380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NZ" sz="1100" dirty="0" smtClean="0"/>
                        <a:t>66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NZ" sz="1100" dirty="0" smtClean="0"/>
                        <a:t>This study</a:t>
                      </a:r>
                      <a:endParaRPr lang="en-NZ" sz="1100" dirty="0"/>
                    </a:p>
                  </a:txBody>
                  <a:tcPr marL="99060" marR="990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00472" y="692696"/>
            <a:ext cx="9433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100" b="1" dirty="0" smtClean="0"/>
              <a:t>Additional </a:t>
            </a:r>
            <a:r>
              <a:rPr lang="en-NZ" sz="1100" b="1" smtClean="0"/>
              <a:t>file </a:t>
            </a:r>
            <a:r>
              <a:rPr lang="en-NZ" sz="1100" b="1" smtClean="0"/>
              <a:t>11</a:t>
            </a:r>
            <a:r>
              <a:rPr lang="en-NZ" sz="1100" smtClean="0"/>
              <a:t>: </a:t>
            </a:r>
            <a:r>
              <a:rPr lang="en-NZ" sz="1100" dirty="0" smtClean="0"/>
              <a:t>A description of </a:t>
            </a:r>
            <a:r>
              <a:rPr lang="en-NZ" sz="1100" dirty="0" err="1" smtClean="0"/>
              <a:t>taxon</a:t>
            </a:r>
            <a:r>
              <a:rPr lang="en-NZ" sz="1100" dirty="0" smtClean="0"/>
              <a:t>-specific primers used for qPCR assays.</a:t>
            </a:r>
            <a:endParaRPr lang="en-NZ" sz="1100" dirty="0"/>
          </a:p>
        </p:txBody>
      </p:sp>
      <p:sp>
        <p:nvSpPr>
          <p:cNvPr id="6" name="TextBox 5"/>
          <p:cNvSpPr txBox="1"/>
          <p:nvPr/>
        </p:nvSpPr>
        <p:spPr>
          <a:xfrm>
            <a:off x="272480" y="3411577"/>
            <a:ext cx="936104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000" dirty="0" smtClean="0"/>
              <a:t>References:</a:t>
            </a:r>
          </a:p>
          <a:p>
            <a:r>
              <a:rPr lang="en-NZ" sz="1000" dirty="0" err="1" smtClean="0"/>
              <a:t>Eisenlord</a:t>
            </a:r>
            <a:r>
              <a:rPr lang="en-NZ" sz="1000" dirty="0" smtClean="0"/>
              <a:t>, S.D., and Zak, D.R. (2010) Simulated atmospheric nitrogen deposition alters </a:t>
            </a:r>
            <a:r>
              <a:rPr lang="en-NZ" sz="1000" dirty="0" err="1" smtClean="0"/>
              <a:t>actinobacterial</a:t>
            </a:r>
            <a:r>
              <a:rPr lang="en-NZ" sz="1000" dirty="0" smtClean="0"/>
              <a:t> community composition in forest soils. </a:t>
            </a:r>
            <a:r>
              <a:rPr lang="en-NZ" sz="1000" i="1" dirty="0" smtClean="0"/>
              <a:t>Soil Science Society of America Journal  </a:t>
            </a:r>
            <a:r>
              <a:rPr lang="en-NZ" sz="1000" b="1" dirty="0" smtClean="0"/>
              <a:t>74</a:t>
            </a:r>
            <a:r>
              <a:rPr lang="en-NZ" sz="1000" dirty="0" smtClean="0"/>
              <a:t>: 1157-1166.</a:t>
            </a:r>
            <a:r>
              <a:rPr lang="en-NZ" sz="1000" i="1" dirty="0" smtClean="0"/>
              <a:t> </a:t>
            </a:r>
          </a:p>
          <a:p>
            <a:r>
              <a:rPr lang="en-NZ" sz="1000" dirty="0" err="1" smtClean="0"/>
              <a:t>Nossa</a:t>
            </a:r>
            <a:r>
              <a:rPr lang="en-NZ" sz="1000" dirty="0" smtClean="0"/>
              <a:t>, C.W., </a:t>
            </a:r>
            <a:r>
              <a:rPr lang="en-NZ" sz="1000" dirty="0" err="1" smtClean="0"/>
              <a:t>Oberdorf</a:t>
            </a:r>
            <a:r>
              <a:rPr lang="en-NZ" sz="1000" dirty="0" smtClean="0"/>
              <a:t>, W.E., Yang, L., </a:t>
            </a:r>
            <a:r>
              <a:rPr lang="en-NZ" sz="1000" dirty="0" err="1" smtClean="0"/>
              <a:t>Aas</a:t>
            </a:r>
            <a:r>
              <a:rPr lang="en-NZ" sz="1000" dirty="0" smtClean="0"/>
              <a:t>, J.A., </a:t>
            </a:r>
            <a:r>
              <a:rPr lang="en-NZ" sz="1000" dirty="0" err="1" smtClean="0"/>
              <a:t>Paster</a:t>
            </a:r>
            <a:r>
              <a:rPr lang="en-NZ" sz="1000" dirty="0" smtClean="0"/>
              <a:t>, B.J., </a:t>
            </a:r>
            <a:r>
              <a:rPr lang="en-NZ" sz="1000" dirty="0" err="1" smtClean="0"/>
              <a:t>DeSantis</a:t>
            </a:r>
            <a:r>
              <a:rPr lang="en-NZ" sz="1000" dirty="0" smtClean="0"/>
              <a:t>, T.Z. et al. (2010) Design of 16S rRNA gene primers for 454 </a:t>
            </a:r>
            <a:r>
              <a:rPr lang="en-NZ" sz="1000" dirty="0" err="1" smtClean="0"/>
              <a:t>pyrosequencing</a:t>
            </a:r>
            <a:r>
              <a:rPr lang="en-NZ" sz="1000" dirty="0" smtClean="0"/>
              <a:t> of the human foregut </a:t>
            </a:r>
            <a:r>
              <a:rPr lang="en-NZ" sz="1000" dirty="0" err="1" smtClean="0"/>
              <a:t>microbiome</a:t>
            </a:r>
            <a:r>
              <a:rPr lang="en-NZ" sz="1000" dirty="0" smtClean="0"/>
              <a:t>. </a:t>
            </a:r>
            <a:r>
              <a:rPr lang="en-NZ" sz="1000" i="1" dirty="0" smtClean="0"/>
              <a:t>World journal of gastroenterology: WJG </a:t>
            </a:r>
            <a:r>
              <a:rPr lang="en-NZ" sz="1000" b="1" dirty="0" smtClean="0"/>
              <a:t>16</a:t>
            </a:r>
            <a:r>
              <a:rPr lang="en-NZ" sz="1000" dirty="0" smtClean="0"/>
              <a:t>: 4135.</a:t>
            </a:r>
          </a:p>
          <a:p>
            <a:r>
              <a:rPr lang="en-NZ" sz="1000" dirty="0" err="1" smtClean="0"/>
              <a:t>Simister</a:t>
            </a:r>
            <a:r>
              <a:rPr lang="en-NZ" sz="1000" dirty="0" smtClean="0"/>
              <a:t>, R., Taylor, M.W., Tsai, P., Fan, L., </a:t>
            </a:r>
            <a:r>
              <a:rPr lang="en-NZ" sz="1000" dirty="0" err="1" smtClean="0"/>
              <a:t>Bruxner</a:t>
            </a:r>
            <a:r>
              <a:rPr lang="en-NZ" sz="1000" dirty="0" smtClean="0"/>
              <a:t>, T.J., Crowe, M.L., and Webster, N. (2012) Thermal stress responses in the bacterial biosphere of the Great Barrier Reef sponge, </a:t>
            </a:r>
            <a:r>
              <a:rPr lang="en-NZ" sz="1000" i="1" dirty="0" err="1" smtClean="0"/>
              <a:t>Rhopaloeides</a:t>
            </a:r>
            <a:r>
              <a:rPr lang="en-NZ" sz="1000" i="1" dirty="0" smtClean="0"/>
              <a:t> </a:t>
            </a:r>
            <a:r>
              <a:rPr lang="en-NZ" sz="1000" i="1" dirty="0" err="1" smtClean="0"/>
              <a:t>odorabile</a:t>
            </a:r>
            <a:r>
              <a:rPr lang="en-NZ" sz="1000" dirty="0" smtClean="0"/>
              <a:t>. </a:t>
            </a:r>
            <a:r>
              <a:rPr lang="en-NZ" sz="1000" i="1" dirty="0" smtClean="0"/>
              <a:t>Environmental Microbiology </a:t>
            </a:r>
            <a:r>
              <a:rPr lang="en-NZ" sz="1000" b="1" dirty="0" smtClean="0"/>
              <a:t>14</a:t>
            </a:r>
            <a:r>
              <a:rPr lang="en-NZ" sz="1000" dirty="0" smtClean="0"/>
              <a:t>: 3232-3246.</a:t>
            </a:r>
            <a:endParaRPr lang="en-NZ" sz="1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4</TotalTime>
  <Words>274</Words>
  <Application>Microsoft Office PowerPoint</Application>
  <PresentationFormat>A4 Paper (210x297 mm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o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dso006</dc:creator>
  <cp:lastModifiedBy>mdso006</cp:lastModifiedBy>
  <cp:revision>9</cp:revision>
  <dcterms:created xsi:type="dcterms:W3CDTF">2013-11-19T20:26:30Z</dcterms:created>
  <dcterms:modified xsi:type="dcterms:W3CDTF">2015-01-24T21:25:40Z</dcterms:modified>
</cp:coreProperties>
</file>